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794F4-E24B-4C3A-8DE7-8644BA2523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8C3AD24-262E-48BC-A448-191201D62E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BA800E-ADA8-477B-BBFC-0A7F899F0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49F798-FD2B-4130-ACB2-CCA3DC4B6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38B6BB-288D-4171-BBDA-DBC99E46E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33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29BC7A-9904-4420-A177-0B4824DBF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F283BAE-8F74-410B-9C96-6E81A5ADDF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A8226A-468B-4546-BA59-89A6AE4B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1E441E-A9B1-4774-BC4F-BBA3F67BA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CB4BFE2-0F35-40C6-B2C3-D3D9A0705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27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5869236-FDC7-4D96-8AED-B5D7E7581F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3B1EF50-7D2A-4748-B2F2-FC4D98C17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E807BD-4786-4C20-8062-8D30011E4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7DCFD0-A0D1-4347-BA44-13D984572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CFA070-029E-4735-BE88-D500ECF1C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512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CB7339-993D-4FA5-983D-A2556545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B47DAD3-E5E8-4B77-90EE-85559A52A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B53BDF-81F5-4F8F-AFDF-5A6B4AA9F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29D9C04-42B6-4127-9843-4FA0C6F18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7C614B-1C4C-4D6D-A0D8-F1F0E9002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189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0A6805-5391-4E95-9FE0-B47BF988E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9AFC12C-9152-4F98-A17C-9BB4D51F8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0902CD-EFDF-4875-A521-8B4E3D081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727A39-7441-4A35-9BE0-EA2CC1AF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C4AE2E-7F80-4136-9A9D-8495C05E6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0263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3131A7-59FC-4143-AFB9-61D62FBD4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1187DF-B6CE-419F-8591-FEA7CB007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F17C53F-EEBA-44A4-93C4-45FE81163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7F3DFA8-CF3D-439D-A4ED-78C2E8B4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EE11231-4D9E-4E7E-BCD9-29E577E60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8DBCEE-06D6-45E6-A437-9A13B38B5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937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1A5D13-433A-4C32-9377-E9E9CB814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96B9F03-B5D8-4411-AF29-0D6DBB765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034E265-D882-4DF4-9616-C77492F73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956D15D-844B-41D2-9C3C-C28AA875E6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E304CC8-348C-4DCE-9D90-43DADF4939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86BCF52-C358-43AA-9AF6-40F6D0FA0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0C02941-E7D3-4F3A-818E-FBF43D25A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6C21B59-AC8C-4F42-BA4D-4BBDEDCC5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302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2FCBAB-BD40-4C04-B815-B861D7474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F55B1DB-BEA0-4D8A-8F3D-EFFDFA5EC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3D4AA13-C723-47DD-AE5D-73E7DA4F3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2C6CC98-7162-4B63-9D10-73387AAD3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5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E06B809-293D-4A41-980C-41F6E8EC7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2783A2A-84E3-4E5D-BC51-18D66AE27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3C0139A-BD26-4D58-BA2D-4C4FFB2E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91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2F73F1-1F5E-47BE-9822-7E8D75CBF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CAA0D1B-CF27-4B03-819E-D30A047BDB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27CEC52-2772-4F6A-9ACB-43562950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9EC593-D518-4752-8BF9-36A51FC5E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1BF9124-C299-487E-87F0-5104F3027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9D7E7BC-F925-4847-8636-7370A4F22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29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A4B86D-21AE-459A-B75D-444345B57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4E9E3C4-9994-458F-B88B-3D1EB2F14B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D3254EA-5F8A-467F-ADC6-16F1533EE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5A3CAB-D840-486C-9249-BEE944D01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007D05F-2401-4BE9-A2C9-29E32A695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EC34F3-15C8-479A-90C6-70CE0D646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3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B40E1D7-86FC-4335-BC71-47C3751E9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FB86F34-1E8F-4059-B9E8-231681B13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3D2838-EAC2-4351-93C6-833B38925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96AB80-D735-4F56-B486-DFADE9AD9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C81C39-724B-4D61-BD6A-9A3850C71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617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 Box 20">
            <a:extLst>
              <a:ext uri="{FF2B5EF4-FFF2-40B4-BE49-F238E27FC236}">
                <a16:creationId xmlns:a16="http://schemas.microsoft.com/office/drawing/2014/main" id="{BCBECBFC-982E-4C38-AF5D-B96FAE2746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4988" y="768024"/>
            <a:ext cx="55335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 S8</a:t>
            </a: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D0589752-6E4B-410E-8D00-1C1E37897E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1667" y="1679109"/>
            <a:ext cx="3106461" cy="215062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2914499-E009-4F0C-BED6-6EC35C492B5A}"/>
              </a:ext>
            </a:extLst>
          </p:cNvPr>
          <p:cNvSpPr txBox="1"/>
          <p:nvPr/>
        </p:nvSpPr>
        <p:spPr>
          <a:xfrm>
            <a:off x="4329246" y="3827816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EF0CFA9-E0FA-4176-92FA-FAC56FF25FC7}"/>
              </a:ext>
            </a:extLst>
          </p:cNvPr>
          <p:cNvSpPr txBox="1"/>
          <p:nvPr/>
        </p:nvSpPr>
        <p:spPr>
          <a:xfrm rot="16200000">
            <a:off x="2232665" y="2615922"/>
            <a:ext cx="996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% Viability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BF2D637D-2D99-4E4B-856C-7B826A8053D0}"/>
              </a:ext>
            </a:extLst>
          </p:cNvPr>
          <p:cNvGrpSpPr/>
          <p:nvPr/>
        </p:nvGrpSpPr>
        <p:grpSpPr>
          <a:xfrm>
            <a:off x="6272528" y="1930577"/>
            <a:ext cx="1895380" cy="1015663"/>
            <a:chOff x="6725533" y="1888632"/>
            <a:chExt cx="1895380" cy="1015663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3A8F7E89-C8DB-4BBD-9F8D-C551CC50680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25533" y="1938968"/>
              <a:ext cx="291326" cy="930068"/>
            </a:xfrm>
            <a:prstGeom prst="rect">
              <a:avLst/>
            </a:prstGeom>
          </p:spPr>
        </p:pic>
        <p:sp>
          <p:nvSpPr>
            <p:cNvPr id="14" name="Text Box 20">
              <a:extLst>
                <a:ext uri="{FF2B5EF4-FFF2-40B4-BE49-F238E27FC236}">
                  <a16:creationId xmlns:a16="http://schemas.microsoft.com/office/drawing/2014/main" id="{8070BD08-9FF6-4E6E-9EAB-F55D4CA69F1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46374" y="1888632"/>
              <a:ext cx="1674539" cy="10156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latinLnBrk="0">
                <a:spcBef>
                  <a:spcPct val="0"/>
                </a:spcBef>
                <a:buFontTx/>
                <a:buNone/>
              </a:pP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bapentin (2.5 mM)</a:t>
              </a:r>
            </a:p>
            <a:p>
              <a:pPr latinLnBrk="0">
                <a:spcBef>
                  <a:spcPct val="0"/>
                </a:spcBef>
                <a:buFontTx/>
                <a:buNone/>
              </a:pP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buprofen (25 mM)</a:t>
              </a:r>
            </a:p>
            <a:p>
              <a:pPr latinLnBrk="0">
                <a:spcBef>
                  <a:spcPct val="0"/>
                </a:spcBef>
                <a:buFontTx/>
                <a:buNone/>
              </a:pP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iclofenac (20 mM)</a:t>
              </a:r>
            </a:p>
            <a:p>
              <a:pPr latinLnBrk="0">
                <a:spcBef>
                  <a:spcPct val="0"/>
                </a:spcBef>
                <a:buFontTx/>
                <a:buNone/>
              </a:pP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mitriptyline (1 mM)</a:t>
              </a:r>
            </a:p>
            <a:p>
              <a:pPr latinLnBrk="0">
                <a:spcBef>
                  <a:spcPct val="0"/>
                </a:spcBef>
                <a:buFontTx/>
                <a:buNone/>
              </a:pP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razodone (0.2 mM)</a:t>
              </a:r>
            </a:p>
            <a:p>
              <a:pPr latinLnBrk="0">
                <a:spcBef>
                  <a:spcPct val="0"/>
                </a:spcBef>
                <a:buFontTx/>
                <a:buNone/>
              </a:pP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enzodiazepine (5 mM)</a:t>
              </a:r>
            </a:p>
          </p:txBody>
        </p:sp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5CDF72E9-83E9-4B2E-8731-08332272D6D6}"/>
              </a:ext>
            </a:extLst>
          </p:cNvPr>
          <p:cNvSpPr/>
          <p:nvPr/>
        </p:nvSpPr>
        <p:spPr>
          <a:xfrm>
            <a:off x="2097972" y="1081090"/>
            <a:ext cx="6096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Viability of </a:t>
            </a:r>
            <a:r>
              <a:rPr lang="en-US" altLang="ko-KR" sz="1200" b="1" i="1" dirty="0"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md-Gal4</a:t>
            </a:r>
            <a:r>
              <a:rPr lang="en-US" altLang="ko-KR" sz="1200" b="1" dirty="0"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 flies </a:t>
            </a:r>
          </a:p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 on normal food supplemented with drugs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0484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</TotalTime>
  <Words>46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aranya Siva</cp:lastModifiedBy>
  <cp:revision>149</cp:revision>
  <dcterms:created xsi:type="dcterms:W3CDTF">2022-10-18T02:31:52Z</dcterms:created>
  <dcterms:modified xsi:type="dcterms:W3CDTF">2023-02-08T08:36:25Z</dcterms:modified>
</cp:coreProperties>
</file>